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AFE2ACB-48F4-4011-B597-7EA2FB2E4D8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1843F30-5D49-4920-B071-C4180E81199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15778EA-EC5F-46E7-B984-48AA758203B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2B42B5E-9A07-4224-BB30-E394D7B8975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2DEC565-D831-462D-8ABF-7465480B55C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5A7AA15-3A14-4985-83B7-22E3468F39C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452B597-62FD-4856-ADC0-D9055F7FBA4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4D6B179-31AB-4123-98B8-15C183DACDC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BA8AB3A-80BB-4E2D-AE6F-F0D390070DE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3B2ECFF-FA1E-48C4-AAA1-03E21451630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C507A41-A2AD-4940-9169-B53266CABF4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A660A7B-25F1-4644-91CB-E4EF0FC8914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2A0C7DD-ED61-46AD-AFFE-47DD71FC73C4}"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3"/>
          <p:cNvSpPr/>
          <p:nvPr/>
        </p:nvSpPr>
        <p:spPr>
          <a:xfrm>
            <a:off x="539640" y="549360"/>
            <a:ext cx="7993080" cy="1189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Supplementary Figure 1: Methylation of the imprinted </a:t>
            </a:r>
            <a:r>
              <a:rPr b="0" i="1" lang="en-GB" sz="1200" spc="-1" strike="noStrike">
                <a:solidFill>
                  <a:srgbClr val="000000"/>
                </a:solidFill>
                <a:latin typeface="Calibri"/>
              </a:rPr>
              <a:t>NHP2L1</a:t>
            </a:r>
            <a:r>
              <a:rPr b="0" lang="en-GB" sz="1200" spc="-1" strike="noStrike">
                <a:solidFill>
                  <a:srgbClr val="000000"/>
                </a:solidFill>
                <a:latin typeface="Calibri"/>
              </a:rPr>
              <a:t> gene in cases with aUPD22q. PCR of bisulphited DNA allowed differential amplification and relative quantification of the methylated (maternal) and unmethylated (paternal) alleles. Methylation values are calculated as the methylated maternal allele peak height divided by the sum of methylated and unmethylated peaks, with control values normalized to zero. Methylation values for control cases therefore lie at 0.0 whilst </a:t>
            </a:r>
            <a:r>
              <a:rPr b="0" i="1" lang="en-GB" sz="1200" spc="-1" strike="noStrike">
                <a:solidFill>
                  <a:srgbClr val="000000"/>
                </a:solidFill>
                <a:latin typeface="Calibri"/>
              </a:rPr>
              <a:t>NHP2L1</a:t>
            </a:r>
            <a:r>
              <a:rPr b="0" lang="en-GB" sz="1200" spc="-1" strike="noStrike">
                <a:solidFill>
                  <a:srgbClr val="000000"/>
                </a:solidFill>
                <a:latin typeface="Calibri"/>
              </a:rPr>
              <a:t> methylation values indicate gain of the maternal allele in two cases and gain of the paternal allele in three cases indicating no parent of origin effect for aUPD22q. Primer sequences are given in Supplementary Table 1.</a:t>
            </a:r>
            <a:endParaRPr b="0" lang="en-US" sz="1200" spc="-1" strike="noStrike">
              <a:solidFill>
                <a:srgbClr val="000000"/>
              </a:solidFill>
              <a:latin typeface="Calibri"/>
            </a:endParaRPr>
          </a:p>
        </p:txBody>
      </p:sp>
      <p:pic>
        <p:nvPicPr>
          <p:cNvPr id="42" name="Picture 4" descr="aUPD22q.jpg"/>
          <p:cNvPicPr/>
          <p:nvPr/>
        </p:nvPicPr>
        <p:blipFill>
          <a:blip r:embed="rId1"/>
          <a:stretch/>
        </p:blipFill>
        <p:spPr>
          <a:xfrm>
            <a:off x="2268360" y="2492280"/>
            <a:ext cx="4427640" cy="377820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4-23T14:52:33Z</dcterms:created>
  <dc:creator>chaseax</dc:creator>
  <dc:description/>
  <dc:language>en-US</dc:language>
  <cp:lastModifiedBy>Satish.d</cp:lastModifiedBy>
  <dcterms:modified xsi:type="dcterms:W3CDTF">2015-07-27T20:53:18Z</dcterms:modified>
  <cp:revision>3</cp:revision>
  <dc:subject/>
  <dc:title>Slide 1</dc:title>
</cp:coreProperties>
</file>